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88"/>
    <p:restoredTop sz="94720"/>
  </p:normalViewPr>
  <p:slideViewPr>
    <p:cSldViewPr snapToGrid="0">
      <p:cViewPr varScale="1">
        <p:scale>
          <a:sx n="157" d="100"/>
          <a:sy n="157" d="100"/>
        </p:scale>
        <p:origin x="176" y="1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342632-02A0-3AA5-9938-639C041CAC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47E11E-60D9-9520-E055-25E72E2C8D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05DF95-9019-191C-525B-DD793C5D9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A07FD-B4B9-63CF-C1FA-CB24DCB1C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C6BE89-29E5-6752-DAE4-E5F6ADAF3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524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380A4E-467E-275F-2CF1-A23406B57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8879C7-F649-5C13-ECB6-186FF012BD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E11240-1A8D-6107-D8F6-F90AE00EB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40043B-A3CD-0189-EDE2-E6EA66F17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F1D6E4-5FED-E69A-560E-F48BB4476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354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975B53-DA7E-2EDE-A2D9-8344EB1FBD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346701-A12E-4668-D060-2D42530EF4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DBBD36-51A1-E5E2-7022-7C5E96649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9F468E-FFA8-D993-A2F0-00E022151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114709-B490-0879-0D9C-0FEBB2EC0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851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400FC-2295-24FE-AD7D-BD678EBA58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AD9CC0-6800-A74A-86BA-ECA2DFC70A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1D6A5E-82F2-4F3A-4772-BCE7EE7E8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30FE4D-9F69-7150-2410-20B3754E8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950C5F-F4FD-2305-BCDB-89383C89E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357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89361-C16A-3B71-3B42-8A6FAEFD1A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439C7C-2797-519D-3AED-D6B0BD0208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A9E64F-9089-5A8D-2D81-B6601CDD2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03EACB-76E5-A0E0-F2C3-E69DD87DA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8EF3FA-8182-4D9F-4DAC-767C78984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860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AD31D2-969D-421B-13D5-507B2C0A34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479F88-0947-27B1-61B2-B16F2C83B4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E91AB2-AC2B-26FF-264D-4566EE183D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A45BC4-7533-162E-50A1-EEBFA5AA7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BB347A-4CC3-CFCA-9F35-7FA7BBF1FF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9F452B-5CC6-0664-FACF-76C789F94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861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A49A4E-18B3-8784-1789-CC3FFE2504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D095F5-0853-9143-CC4E-7DBBE23EB1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1261D5-38A0-02EE-4671-72102151B2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3B1948-3DAE-5845-8CE0-37F346E5FB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EFFC75-17B5-F9E0-49BD-578D6A9DDF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39F79A-8F3A-B562-6DF7-9A57C230B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AE7BE2-039F-1750-AB79-574074500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CC149FC-01A9-A80B-8A67-9187ED2B6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892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99665-0679-A07C-6C33-D67C2D255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63483E-0D69-36FA-743F-C44645F73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6F53814-6D76-4C2D-15E7-97F92345B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D29B10-85C4-B12C-582D-557785C24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56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2F73B0-1735-BA7C-7146-1CA8A4CBE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73E0E5-48CC-25C7-A8A1-4535D8D9B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9461705-8C8D-C27D-26B3-20C777297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074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84F637-8FE0-359D-CB04-6B45C8177B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0C7C74-C2F2-FF8B-CF56-3D1F244E44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DEF42C-2CC6-ACE3-EBED-A79E8EA26B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8F6CF7-C84D-B544-AE30-CA567420B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57F12C-FB43-A0B9-346B-18933579EB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84C6BB-D4F4-04B7-2F33-E1FB9771D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318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51E0A-7EDB-D799-6A5A-1CDFCC0CD1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E00E5D-584A-1412-9CA2-F04885352F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F37BD8-8832-0800-4001-99476D9EBA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5FA96-47FA-AC3D-E1D0-8BC48019C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C752F9-5DB0-8A41-75F5-012380F58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A9AA8C-E8C9-C656-3690-225DA5837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740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3BD340D-AF74-4FD7-237E-EDB910F00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C8BBAB-69A9-12A4-29F5-8B91425996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4C5E88-6BBC-8F17-8E1E-23FA63E84E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4A0A8-09ED-644F-A640-96AB7D299CA6}" type="datetimeFigureOut">
              <a:rPr lang="en-US" smtClean="0"/>
              <a:t>10/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CCCAB2-226A-0964-057E-7AB8708ACA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5FAFBA-C827-567A-C8B3-65B4FD9F12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FE42E-83AF-8B44-9AC9-06421AFC9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13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ge-lab.org/idep/" TargetMode="Externa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C8E786A-0EEE-8E4F-8D97-BDD4B1F28A6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82" r="5265" b="6333"/>
          <a:stretch/>
        </p:blipFill>
        <p:spPr>
          <a:xfrm>
            <a:off x="713545" y="0"/>
            <a:ext cx="7462888" cy="488725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8177062-20BA-C227-8BE0-66345838A7B6}"/>
              </a:ext>
            </a:extLst>
          </p:cNvPr>
          <p:cNvSpPr txBox="1"/>
          <p:nvPr/>
        </p:nvSpPr>
        <p:spPr>
          <a:xfrm>
            <a:off x="861146" y="4776604"/>
            <a:ext cx="15840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bbit proteins in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fed tik mouthpart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D4F22EB-9404-D6F2-1786-D244E9759BD4}"/>
              </a:ext>
            </a:extLst>
          </p:cNvPr>
          <p:cNvSpPr txBox="1"/>
          <p:nvPr/>
        </p:nvSpPr>
        <p:spPr>
          <a:xfrm>
            <a:off x="2521870" y="4739595"/>
            <a:ext cx="14300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bbit proteins associated with 6 h fed tick ce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721E353-3441-883E-31DA-84AAE4AFB628}"/>
              </a:ext>
            </a:extLst>
          </p:cNvPr>
          <p:cNvSpPr txBox="1"/>
          <p:nvPr/>
        </p:nvSpPr>
        <p:spPr>
          <a:xfrm>
            <a:off x="3951907" y="4776604"/>
            <a:ext cx="14300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bbit proteins associated with 24 h fed tick cement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F97C336-D6EF-53F9-0623-1E85BDC71DE5}"/>
              </a:ext>
            </a:extLst>
          </p:cNvPr>
          <p:cNvSpPr/>
          <p:nvPr/>
        </p:nvSpPr>
        <p:spPr>
          <a:xfrm>
            <a:off x="713546" y="121574"/>
            <a:ext cx="7462887" cy="616593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3DF3DFF-1CF6-9143-AE99-5B41401E5BE7}"/>
              </a:ext>
            </a:extLst>
          </p:cNvPr>
          <p:cNvSpPr txBox="1"/>
          <p:nvPr/>
        </p:nvSpPr>
        <p:spPr>
          <a:xfrm>
            <a:off x="713545" y="5379024"/>
            <a:ext cx="746288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1: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lative abundance of rabbit proteins that were associated with cement of 6 and 24 h attached ticks. Normalized spectral abundance factor were loaded into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DEP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integrated Differential Expression and Pathway analysis; </a:t>
            </a:r>
            <a:r>
              <a:rPr lang="en-US" sz="120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3"/>
              </a:rPr>
              <a:t>http://ge-lab.org/idep/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to generate the heat map.  Accession numbers of tick cement proteins in different clusters of the heatmap are listed in supplemental table 1B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258816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94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lenga, Albert</dc:creator>
  <cp:lastModifiedBy>Albert Mulenga</cp:lastModifiedBy>
  <cp:revision>5</cp:revision>
  <dcterms:created xsi:type="dcterms:W3CDTF">2022-10-04T23:59:39Z</dcterms:created>
  <dcterms:modified xsi:type="dcterms:W3CDTF">2022-10-06T17:12:21Z</dcterms:modified>
</cp:coreProperties>
</file>